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4C2A6D-0D1D-4F02-87C0-C4AF74CB4EF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C451BF-14E1-48DA-A285-E4155802AB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C3100A-ABB5-4EEF-ABE4-B7DD66455B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01B455-AD42-42FF-841C-E8C8C06CAEE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6F11C2-0EAA-4AA4-A6B0-FAF69F3B4A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A52EC-3E4F-4490-8ECD-C1076240C3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31DD8-5C62-4113-8FA7-705A2CC77D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8E4C6C-1932-4301-8023-1E614F125F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45E90E-C12E-456D-84ED-C8F8921B33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62CBB-AA28-4D11-8811-C265DC613A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3AB0FC-8373-4F4B-87B6-DF9D9475D7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77F0F-14EA-4B6C-83E3-775553C4C0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FE2737-0CAC-495A-A3BF-95CA0E5C8095}" type="slidenum">
              <a:rPr b="0" lang="ja-JP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77360" y="1200240"/>
            <a:ext cx="87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59000" y="420840"/>
            <a:ext cx="2661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INFORMA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97000" y="6861240"/>
            <a:ext cx="6372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Genomic distribution of 66 ENORs. 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The chromosomal location for individual ENORs is shown. Regions that mapped on the + strand and - strand are located above and below the line respectively. Transcribed protein-coding and noncoding regions were also mapped to the genome, and are shown in blue and red.</a:t>
            </a:r>
            <a:r>
              <a:rPr b="0" lang="ja-JP" sz="1200" spc="-1" strike="noStrike">
                <a:solidFill>
                  <a:srgbClr val="000000"/>
                </a:solidFill>
                <a:latin typeface="Times New Roman"/>
                <a:ea typeface="ＭＳ 明朝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620640" y="1857240"/>
            <a:ext cx="5757840" cy="4216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4-15T01:47:05Z</dcterms:created>
  <dc:creator> </dc:creator>
  <dc:description/>
  <dc:language>en-US</dc:language>
  <cp:lastModifiedBy> </cp:lastModifiedBy>
  <dcterms:modified xsi:type="dcterms:W3CDTF">2006-02-01T00:34:21Z</dcterms:modified>
  <cp:revision>88</cp:revision>
  <dc:subject/>
  <dc:title>スライド 1</dc:title>
</cp:coreProperties>
</file>